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12192000" cy="79375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271"/>
  </p:normalViewPr>
  <p:slideViewPr>
    <p:cSldViewPr snapToGrid="0">
      <p:cViewPr varScale="1">
        <p:scale>
          <a:sx n="93" d="100"/>
          <a:sy n="93" d="100"/>
        </p:scale>
        <p:origin x="13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299031"/>
            <a:ext cx="10363200" cy="2763426"/>
          </a:xfrm>
        </p:spPr>
        <p:txBody>
          <a:bodyPr anchor="b"/>
          <a:lstStyle>
            <a:lvl1pPr algn="ctr">
              <a:defRPr sz="694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169026"/>
            <a:ext cx="9144000" cy="1916391"/>
          </a:xfrm>
        </p:spPr>
        <p:txBody>
          <a:bodyPr/>
          <a:lstStyle>
            <a:lvl1pPr marL="0" indent="0" algn="ctr">
              <a:buNone/>
              <a:defRPr sz="2778"/>
            </a:lvl1pPr>
            <a:lvl2pPr marL="529163" indent="0" algn="ctr">
              <a:buNone/>
              <a:defRPr sz="2315"/>
            </a:lvl2pPr>
            <a:lvl3pPr marL="1058327" indent="0" algn="ctr">
              <a:buNone/>
              <a:defRPr sz="2083"/>
            </a:lvl3pPr>
            <a:lvl4pPr marL="1587490" indent="0" algn="ctr">
              <a:buNone/>
              <a:defRPr sz="1852"/>
            </a:lvl4pPr>
            <a:lvl5pPr marL="2116653" indent="0" algn="ctr">
              <a:buNone/>
              <a:defRPr sz="1852"/>
            </a:lvl5pPr>
            <a:lvl6pPr marL="2645816" indent="0" algn="ctr">
              <a:buNone/>
              <a:defRPr sz="1852"/>
            </a:lvl6pPr>
            <a:lvl7pPr marL="3174980" indent="0" algn="ctr">
              <a:buNone/>
              <a:defRPr sz="1852"/>
            </a:lvl7pPr>
            <a:lvl8pPr marL="3704143" indent="0" algn="ctr">
              <a:buNone/>
              <a:defRPr sz="1852"/>
            </a:lvl8pPr>
            <a:lvl9pPr marL="4233306" indent="0" algn="ctr">
              <a:buNone/>
              <a:defRPr sz="1852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3303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2945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22599"/>
            <a:ext cx="2628900" cy="6726664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22599"/>
            <a:ext cx="7734300" cy="6726664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5244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076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978865"/>
            <a:ext cx="10515600" cy="3301779"/>
          </a:xfrm>
        </p:spPr>
        <p:txBody>
          <a:bodyPr anchor="b"/>
          <a:lstStyle>
            <a:lvl1pPr>
              <a:defRPr sz="694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5311880"/>
            <a:ext cx="10515600" cy="1736328"/>
          </a:xfrm>
        </p:spPr>
        <p:txBody>
          <a:bodyPr/>
          <a:lstStyle>
            <a:lvl1pPr marL="0" indent="0">
              <a:buNone/>
              <a:defRPr sz="2778">
                <a:solidFill>
                  <a:schemeClr val="tx1"/>
                </a:solidFill>
              </a:defRPr>
            </a:lvl1pPr>
            <a:lvl2pPr marL="529163" indent="0">
              <a:buNone/>
              <a:defRPr sz="2315">
                <a:solidFill>
                  <a:schemeClr val="tx1">
                    <a:tint val="75000"/>
                  </a:schemeClr>
                </a:solidFill>
              </a:defRPr>
            </a:lvl2pPr>
            <a:lvl3pPr marL="1058327" indent="0">
              <a:buNone/>
              <a:defRPr sz="2083">
                <a:solidFill>
                  <a:schemeClr val="tx1">
                    <a:tint val="75000"/>
                  </a:schemeClr>
                </a:solidFill>
              </a:defRPr>
            </a:lvl3pPr>
            <a:lvl4pPr marL="1587490" indent="0">
              <a:buNone/>
              <a:defRPr sz="1852">
                <a:solidFill>
                  <a:schemeClr val="tx1">
                    <a:tint val="75000"/>
                  </a:schemeClr>
                </a:solidFill>
              </a:defRPr>
            </a:lvl4pPr>
            <a:lvl5pPr marL="2116653" indent="0">
              <a:buNone/>
              <a:defRPr sz="1852">
                <a:solidFill>
                  <a:schemeClr val="tx1">
                    <a:tint val="75000"/>
                  </a:schemeClr>
                </a:solidFill>
              </a:defRPr>
            </a:lvl5pPr>
            <a:lvl6pPr marL="2645816" indent="0">
              <a:buNone/>
              <a:defRPr sz="1852">
                <a:solidFill>
                  <a:schemeClr val="tx1">
                    <a:tint val="75000"/>
                  </a:schemeClr>
                </a:solidFill>
              </a:defRPr>
            </a:lvl6pPr>
            <a:lvl7pPr marL="3174980" indent="0">
              <a:buNone/>
              <a:defRPr sz="1852">
                <a:solidFill>
                  <a:schemeClr val="tx1">
                    <a:tint val="75000"/>
                  </a:schemeClr>
                </a:solidFill>
              </a:defRPr>
            </a:lvl7pPr>
            <a:lvl8pPr marL="3704143" indent="0">
              <a:buNone/>
              <a:defRPr sz="1852">
                <a:solidFill>
                  <a:schemeClr val="tx1">
                    <a:tint val="75000"/>
                  </a:schemeClr>
                </a:solidFill>
              </a:defRPr>
            </a:lvl8pPr>
            <a:lvl9pPr marL="4233306" indent="0">
              <a:buNone/>
              <a:defRPr sz="185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1130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112992"/>
            <a:ext cx="5181600" cy="503627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112992"/>
            <a:ext cx="5181600" cy="5036271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8515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22600"/>
            <a:ext cx="10515600" cy="153421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945790"/>
            <a:ext cx="5157787" cy="953602"/>
          </a:xfrm>
        </p:spPr>
        <p:txBody>
          <a:bodyPr anchor="b"/>
          <a:lstStyle>
            <a:lvl1pPr marL="0" indent="0">
              <a:buNone/>
              <a:defRPr sz="2778" b="1"/>
            </a:lvl1pPr>
            <a:lvl2pPr marL="529163" indent="0">
              <a:buNone/>
              <a:defRPr sz="2315" b="1"/>
            </a:lvl2pPr>
            <a:lvl3pPr marL="1058327" indent="0">
              <a:buNone/>
              <a:defRPr sz="2083" b="1"/>
            </a:lvl3pPr>
            <a:lvl4pPr marL="1587490" indent="0">
              <a:buNone/>
              <a:defRPr sz="1852" b="1"/>
            </a:lvl4pPr>
            <a:lvl5pPr marL="2116653" indent="0">
              <a:buNone/>
              <a:defRPr sz="1852" b="1"/>
            </a:lvl5pPr>
            <a:lvl6pPr marL="2645816" indent="0">
              <a:buNone/>
              <a:defRPr sz="1852" b="1"/>
            </a:lvl6pPr>
            <a:lvl7pPr marL="3174980" indent="0">
              <a:buNone/>
              <a:defRPr sz="1852" b="1"/>
            </a:lvl7pPr>
            <a:lvl8pPr marL="3704143" indent="0">
              <a:buNone/>
              <a:defRPr sz="1852" b="1"/>
            </a:lvl8pPr>
            <a:lvl9pPr marL="4233306" indent="0">
              <a:buNone/>
              <a:defRPr sz="185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899393"/>
            <a:ext cx="5157787" cy="426456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45790"/>
            <a:ext cx="5183188" cy="953602"/>
          </a:xfrm>
        </p:spPr>
        <p:txBody>
          <a:bodyPr anchor="b"/>
          <a:lstStyle>
            <a:lvl1pPr marL="0" indent="0">
              <a:buNone/>
              <a:defRPr sz="2778" b="1"/>
            </a:lvl1pPr>
            <a:lvl2pPr marL="529163" indent="0">
              <a:buNone/>
              <a:defRPr sz="2315" b="1"/>
            </a:lvl2pPr>
            <a:lvl3pPr marL="1058327" indent="0">
              <a:buNone/>
              <a:defRPr sz="2083" b="1"/>
            </a:lvl3pPr>
            <a:lvl4pPr marL="1587490" indent="0">
              <a:buNone/>
              <a:defRPr sz="1852" b="1"/>
            </a:lvl4pPr>
            <a:lvl5pPr marL="2116653" indent="0">
              <a:buNone/>
              <a:defRPr sz="1852" b="1"/>
            </a:lvl5pPr>
            <a:lvl6pPr marL="2645816" indent="0">
              <a:buNone/>
              <a:defRPr sz="1852" b="1"/>
            </a:lvl6pPr>
            <a:lvl7pPr marL="3174980" indent="0">
              <a:buNone/>
              <a:defRPr sz="1852" b="1"/>
            </a:lvl7pPr>
            <a:lvl8pPr marL="3704143" indent="0">
              <a:buNone/>
              <a:defRPr sz="1852" b="1"/>
            </a:lvl8pPr>
            <a:lvl9pPr marL="4233306" indent="0">
              <a:buNone/>
              <a:defRPr sz="185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99393"/>
            <a:ext cx="5183188" cy="426456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7879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8821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7389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9167"/>
            <a:ext cx="3932237" cy="1852083"/>
          </a:xfrm>
        </p:spPr>
        <p:txBody>
          <a:bodyPr anchor="b"/>
          <a:lstStyle>
            <a:lvl1pPr>
              <a:defRPr sz="370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42855"/>
            <a:ext cx="6172200" cy="5640770"/>
          </a:xfrm>
        </p:spPr>
        <p:txBody>
          <a:bodyPr/>
          <a:lstStyle>
            <a:lvl1pPr>
              <a:defRPr sz="3704"/>
            </a:lvl1pPr>
            <a:lvl2pPr>
              <a:defRPr sz="3241"/>
            </a:lvl2pPr>
            <a:lvl3pPr>
              <a:defRPr sz="2778"/>
            </a:lvl3pPr>
            <a:lvl4pPr>
              <a:defRPr sz="2315"/>
            </a:lvl4pPr>
            <a:lvl5pPr>
              <a:defRPr sz="2315"/>
            </a:lvl5pPr>
            <a:lvl6pPr>
              <a:defRPr sz="2315"/>
            </a:lvl6pPr>
            <a:lvl7pPr>
              <a:defRPr sz="2315"/>
            </a:lvl7pPr>
            <a:lvl8pPr>
              <a:defRPr sz="2315"/>
            </a:lvl8pPr>
            <a:lvl9pPr>
              <a:defRPr sz="231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81250"/>
            <a:ext cx="3932237" cy="4411560"/>
          </a:xfrm>
        </p:spPr>
        <p:txBody>
          <a:bodyPr/>
          <a:lstStyle>
            <a:lvl1pPr marL="0" indent="0">
              <a:buNone/>
              <a:defRPr sz="1852"/>
            </a:lvl1pPr>
            <a:lvl2pPr marL="529163" indent="0">
              <a:buNone/>
              <a:defRPr sz="1620"/>
            </a:lvl2pPr>
            <a:lvl3pPr marL="1058327" indent="0">
              <a:buNone/>
              <a:defRPr sz="1389"/>
            </a:lvl3pPr>
            <a:lvl4pPr marL="1587490" indent="0">
              <a:buNone/>
              <a:defRPr sz="1157"/>
            </a:lvl4pPr>
            <a:lvl5pPr marL="2116653" indent="0">
              <a:buNone/>
              <a:defRPr sz="1157"/>
            </a:lvl5pPr>
            <a:lvl6pPr marL="2645816" indent="0">
              <a:buNone/>
              <a:defRPr sz="1157"/>
            </a:lvl6pPr>
            <a:lvl7pPr marL="3174980" indent="0">
              <a:buNone/>
              <a:defRPr sz="1157"/>
            </a:lvl7pPr>
            <a:lvl8pPr marL="3704143" indent="0">
              <a:buNone/>
              <a:defRPr sz="1157"/>
            </a:lvl8pPr>
            <a:lvl9pPr marL="4233306" indent="0">
              <a:buNone/>
              <a:defRPr sz="115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2564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29167"/>
            <a:ext cx="3932237" cy="1852083"/>
          </a:xfrm>
        </p:spPr>
        <p:txBody>
          <a:bodyPr anchor="b"/>
          <a:lstStyle>
            <a:lvl1pPr>
              <a:defRPr sz="370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42855"/>
            <a:ext cx="6172200" cy="5640770"/>
          </a:xfrm>
        </p:spPr>
        <p:txBody>
          <a:bodyPr anchor="t"/>
          <a:lstStyle>
            <a:lvl1pPr marL="0" indent="0">
              <a:buNone/>
              <a:defRPr sz="3704"/>
            </a:lvl1pPr>
            <a:lvl2pPr marL="529163" indent="0">
              <a:buNone/>
              <a:defRPr sz="3241"/>
            </a:lvl2pPr>
            <a:lvl3pPr marL="1058327" indent="0">
              <a:buNone/>
              <a:defRPr sz="2778"/>
            </a:lvl3pPr>
            <a:lvl4pPr marL="1587490" indent="0">
              <a:buNone/>
              <a:defRPr sz="2315"/>
            </a:lvl4pPr>
            <a:lvl5pPr marL="2116653" indent="0">
              <a:buNone/>
              <a:defRPr sz="2315"/>
            </a:lvl5pPr>
            <a:lvl6pPr marL="2645816" indent="0">
              <a:buNone/>
              <a:defRPr sz="2315"/>
            </a:lvl6pPr>
            <a:lvl7pPr marL="3174980" indent="0">
              <a:buNone/>
              <a:defRPr sz="2315"/>
            </a:lvl7pPr>
            <a:lvl8pPr marL="3704143" indent="0">
              <a:buNone/>
              <a:defRPr sz="2315"/>
            </a:lvl8pPr>
            <a:lvl9pPr marL="4233306" indent="0">
              <a:buNone/>
              <a:defRPr sz="2315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381250"/>
            <a:ext cx="3932237" cy="4411560"/>
          </a:xfrm>
        </p:spPr>
        <p:txBody>
          <a:bodyPr/>
          <a:lstStyle>
            <a:lvl1pPr marL="0" indent="0">
              <a:buNone/>
              <a:defRPr sz="1852"/>
            </a:lvl1pPr>
            <a:lvl2pPr marL="529163" indent="0">
              <a:buNone/>
              <a:defRPr sz="1620"/>
            </a:lvl2pPr>
            <a:lvl3pPr marL="1058327" indent="0">
              <a:buNone/>
              <a:defRPr sz="1389"/>
            </a:lvl3pPr>
            <a:lvl4pPr marL="1587490" indent="0">
              <a:buNone/>
              <a:defRPr sz="1157"/>
            </a:lvl4pPr>
            <a:lvl5pPr marL="2116653" indent="0">
              <a:buNone/>
              <a:defRPr sz="1157"/>
            </a:lvl5pPr>
            <a:lvl6pPr marL="2645816" indent="0">
              <a:buNone/>
              <a:defRPr sz="1157"/>
            </a:lvl6pPr>
            <a:lvl7pPr marL="3174980" indent="0">
              <a:buNone/>
              <a:defRPr sz="1157"/>
            </a:lvl7pPr>
            <a:lvl8pPr marL="3704143" indent="0">
              <a:buNone/>
              <a:defRPr sz="1157"/>
            </a:lvl8pPr>
            <a:lvl9pPr marL="4233306" indent="0">
              <a:buNone/>
              <a:defRPr sz="1157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9192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22600"/>
            <a:ext cx="10515600" cy="15342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112992"/>
            <a:ext cx="10515600" cy="50362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356889"/>
            <a:ext cx="2743200" cy="4225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06674-34F1-5647-902B-EF6B64759662}" type="datetimeFigureOut">
              <a:rPr lang="es-ES" smtClean="0"/>
              <a:t>14/4/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356889"/>
            <a:ext cx="4114800" cy="4225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356889"/>
            <a:ext cx="2743200" cy="42259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579370-A79A-4C49-AC27-6BB551762FC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1034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58327" rtl="0" eaLnBrk="1" latinLnBrk="0" hangingPunct="1">
        <a:lnSpc>
          <a:spcPct val="90000"/>
        </a:lnSpc>
        <a:spcBef>
          <a:spcPct val="0"/>
        </a:spcBef>
        <a:buNone/>
        <a:defRPr sz="509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4582" indent="-264582" algn="l" defTabSz="1058327" rtl="0" eaLnBrk="1" latinLnBrk="0" hangingPunct="1">
        <a:lnSpc>
          <a:spcPct val="90000"/>
        </a:lnSpc>
        <a:spcBef>
          <a:spcPts val="1157"/>
        </a:spcBef>
        <a:buFont typeface="Arial" panose="020B0604020202020204" pitchFamily="34" charset="0"/>
        <a:buChar char="•"/>
        <a:defRPr sz="3241" kern="1200">
          <a:solidFill>
            <a:schemeClr val="tx1"/>
          </a:solidFill>
          <a:latin typeface="+mn-lt"/>
          <a:ea typeface="+mn-ea"/>
          <a:cs typeface="+mn-cs"/>
        </a:defRPr>
      </a:lvl1pPr>
      <a:lvl2pPr marL="793745" indent="-264582" algn="l" defTabSz="1058327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778" kern="1200">
          <a:solidFill>
            <a:schemeClr val="tx1"/>
          </a:solidFill>
          <a:latin typeface="+mn-lt"/>
          <a:ea typeface="+mn-ea"/>
          <a:cs typeface="+mn-cs"/>
        </a:defRPr>
      </a:lvl2pPr>
      <a:lvl3pPr marL="1322908" indent="-264582" algn="l" defTabSz="1058327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3pPr>
      <a:lvl4pPr marL="1852071" indent="-264582" algn="l" defTabSz="1058327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3" kern="1200">
          <a:solidFill>
            <a:schemeClr val="tx1"/>
          </a:solidFill>
          <a:latin typeface="+mn-lt"/>
          <a:ea typeface="+mn-ea"/>
          <a:cs typeface="+mn-cs"/>
        </a:defRPr>
      </a:lvl4pPr>
      <a:lvl5pPr marL="2381235" indent="-264582" algn="l" defTabSz="1058327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3" kern="1200">
          <a:solidFill>
            <a:schemeClr val="tx1"/>
          </a:solidFill>
          <a:latin typeface="+mn-lt"/>
          <a:ea typeface="+mn-ea"/>
          <a:cs typeface="+mn-cs"/>
        </a:defRPr>
      </a:lvl5pPr>
      <a:lvl6pPr marL="2910398" indent="-264582" algn="l" defTabSz="1058327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3" kern="1200">
          <a:solidFill>
            <a:schemeClr val="tx1"/>
          </a:solidFill>
          <a:latin typeface="+mn-lt"/>
          <a:ea typeface="+mn-ea"/>
          <a:cs typeface="+mn-cs"/>
        </a:defRPr>
      </a:lvl6pPr>
      <a:lvl7pPr marL="3439561" indent="-264582" algn="l" defTabSz="1058327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3" kern="1200">
          <a:solidFill>
            <a:schemeClr val="tx1"/>
          </a:solidFill>
          <a:latin typeface="+mn-lt"/>
          <a:ea typeface="+mn-ea"/>
          <a:cs typeface="+mn-cs"/>
        </a:defRPr>
      </a:lvl7pPr>
      <a:lvl8pPr marL="3968725" indent="-264582" algn="l" defTabSz="1058327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3" kern="1200">
          <a:solidFill>
            <a:schemeClr val="tx1"/>
          </a:solidFill>
          <a:latin typeface="+mn-lt"/>
          <a:ea typeface="+mn-ea"/>
          <a:cs typeface="+mn-cs"/>
        </a:defRPr>
      </a:lvl8pPr>
      <a:lvl9pPr marL="4497888" indent="-264582" algn="l" defTabSz="1058327" rtl="0" eaLnBrk="1" latinLnBrk="0" hangingPunct="1">
        <a:lnSpc>
          <a:spcPct val="90000"/>
        </a:lnSpc>
        <a:spcBef>
          <a:spcPts val="579"/>
        </a:spcBef>
        <a:buFont typeface="Arial" panose="020B0604020202020204" pitchFamily="34" charset="0"/>
        <a:buChar char="•"/>
        <a:defRPr sz="208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58327" rtl="0" eaLnBrk="1" latinLnBrk="0" hangingPunct="1">
        <a:defRPr sz="2083" kern="1200">
          <a:solidFill>
            <a:schemeClr val="tx1"/>
          </a:solidFill>
          <a:latin typeface="+mn-lt"/>
          <a:ea typeface="+mn-ea"/>
          <a:cs typeface="+mn-cs"/>
        </a:defRPr>
      </a:lvl1pPr>
      <a:lvl2pPr marL="529163" algn="l" defTabSz="1058327" rtl="0" eaLnBrk="1" latinLnBrk="0" hangingPunct="1">
        <a:defRPr sz="2083" kern="1200">
          <a:solidFill>
            <a:schemeClr val="tx1"/>
          </a:solidFill>
          <a:latin typeface="+mn-lt"/>
          <a:ea typeface="+mn-ea"/>
          <a:cs typeface="+mn-cs"/>
        </a:defRPr>
      </a:lvl2pPr>
      <a:lvl3pPr marL="1058327" algn="l" defTabSz="1058327" rtl="0" eaLnBrk="1" latinLnBrk="0" hangingPunct="1">
        <a:defRPr sz="2083" kern="1200">
          <a:solidFill>
            <a:schemeClr val="tx1"/>
          </a:solidFill>
          <a:latin typeface="+mn-lt"/>
          <a:ea typeface="+mn-ea"/>
          <a:cs typeface="+mn-cs"/>
        </a:defRPr>
      </a:lvl3pPr>
      <a:lvl4pPr marL="1587490" algn="l" defTabSz="1058327" rtl="0" eaLnBrk="1" latinLnBrk="0" hangingPunct="1">
        <a:defRPr sz="2083" kern="1200">
          <a:solidFill>
            <a:schemeClr val="tx1"/>
          </a:solidFill>
          <a:latin typeface="+mn-lt"/>
          <a:ea typeface="+mn-ea"/>
          <a:cs typeface="+mn-cs"/>
        </a:defRPr>
      </a:lvl4pPr>
      <a:lvl5pPr marL="2116653" algn="l" defTabSz="1058327" rtl="0" eaLnBrk="1" latinLnBrk="0" hangingPunct="1">
        <a:defRPr sz="2083" kern="1200">
          <a:solidFill>
            <a:schemeClr val="tx1"/>
          </a:solidFill>
          <a:latin typeface="+mn-lt"/>
          <a:ea typeface="+mn-ea"/>
          <a:cs typeface="+mn-cs"/>
        </a:defRPr>
      </a:lvl5pPr>
      <a:lvl6pPr marL="2645816" algn="l" defTabSz="1058327" rtl="0" eaLnBrk="1" latinLnBrk="0" hangingPunct="1">
        <a:defRPr sz="2083" kern="1200">
          <a:solidFill>
            <a:schemeClr val="tx1"/>
          </a:solidFill>
          <a:latin typeface="+mn-lt"/>
          <a:ea typeface="+mn-ea"/>
          <a:cs typeface="+mn-cs"/>
        </a:defRPr>
      </a:lvl6pPr>
      <a:lvl7pPr marL="3174980" algn="l" defTabSz="1058327" rtl="0" eaLnBrk="1" latinLnBrk="0" hangingPunct="1">
        <a:defRPr sz="2083" kern="1200">
          <a:solidFill>
            <a:schemeClr val="tx1"/>
          </a:solidFill>
          <a:latin typeface="+mn-lt"/>
          <a:ea typeface="+mn-ea"/>
          <a:cs typeface="+mn-cs"/>
        </a:defRPr>
      </a:lvl7pPr>
      <a:lvl8pPr marL="3704143" algn="l" defTabSz="1058327" rtl="0" eaLnBrk="1" latinLnBrk="0" hangingPunct="1">
        <a:defRPr sz="2083" kern="1200">
          <a:solidFill>
            <a:schemeClr val="tx1"/>
          </a:solidFill>
          <a:latin typeface="+mn-lt"/>
          <a:ea typeface="+mn-ea"/>
          <a:cs typeface="+mn-cs"/>
        </a:defRPr>
      </a:lvl8pPr>
      <a:lvl9pPr marL="4233306" algn="l" defTabSz="1058327" rtl="0" eaLnBrk="1" latinLnBrk="0" hangingPunct="1">
        <a:defRPr sz="208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28FA7086-ECC0-1625-1CB0-7FDA98D47588}"/>
              </a:ext>
            </a:extLst>
          </p:cNvPr>
          <p:cNvSpPr txBox="1"/>
          <p:nvPr/>
        </p:nvSpPr>
        <p:spPr>
          <a:xfrm>
            <a:off x="107922" y="539750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graphicFrame>
        <p:nvGraphicFramePr>
          <p:cNvPr id="7" name="Tabla 26">
            <a:extLst>
              <a:ext uri="{FF2B5EF4-FFF2-40B4-BE49-F238E27FC236}">
                <a16:creationId xmlns:a16="http://schemas.microsoft.com/office/drawing/2014/main" id="{271F62AA-D873-461B-AA59-06A5E1614B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8294961"/>
              </p:ext>
            </p:extLst>
          </p:nvPr>
        </p:nvGraphicFramePr>
        <p:xfrm>
          <a:off x="4135763" y="859274"/>
          <a:ext cx="3626922" cy="2301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14823">
                  <a:extLst>
                    <a:ext uri="{9D8B030D-6E8A-4147-A177-3AD203B41FA5}">
                      <a16:colId xmlns:a16="http://schemas.microsoft.com/office/drawing/2014/main" val="1619431056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37871101"/>
                    </a:ext>
                  </a:extLst>
                </a:gridCol>
                <a:gridCol w="802640">
                  <a:extLst>
                    <a:ext uri="{9D8B030D-6E8A-4147-A177-3AD203B41FA5}">
                      <a16:colId xmlns:a16="http://schemas.microsoft.com/office/drawing/2014/main" val="155314303"/>
                    </a:ext>
                  </a:extLst>
                </a:gridCol>
                <a:gridCol w="844259">
                  <a:extLst>
                    <a:ext uri="{9D8B030D-6E8A-4147-A177-3AD203B41FA5}">
                      <a16:colId xmlns:a16="http://schemas.microsoft.com/office/drawing/2014/main" val="3197434678"/>
                    </a:ext>
                  </a:extLst>
                </a:gridCol>
              </a:tblGrid>
              <a:tr h="217643">
                <a:tc rowSpan="2" gridSpan="2">
                  <a:txBody>
                    <a:bodyPr/>
                    <a:lstStyle/>
                    <a:p>
                      <a:pPr algn="ctr"/>
                      <a:endParaRPr lang="en-US" sz="11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dict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3411237"/>
                  </a:ext>
                </a:extLst>
              </a:tr>
              <a:tr h="358470">
                <a:tc gridSpan="2" v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-nourish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ll-nourish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8253269"/>
                  </a:ext>
                </a:extLst>
              </a:tr>
              <a:tr h="358470">
                <a:tc rowSpan="2">
                  <a:txBody>
                    <a:bodyPr/>
                    <a:lstStyle/>
                    <a:p>
                      <a:pPr algn="ctr"/>
                      <a:endParaRPr lang="en-US" sz="11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1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bserv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-nourish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0171736"/>
                  </a:ext>
                </a:extLst>
              </a:tr>
              <a:tr h="358470">
                <a:tc v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ll-nourish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6</a:t>
                      </a: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8284739"/>
                  </a:ext>
                </a:extLst>
              </a:tr>
              <a:tr h="642425">
                <a:tc gridSpan="4">
                  <a:txBody>
                    <a:bodyPr/>
                    <a:lstStyle/>
                    <a:p>
                      <a:pPr algn="ctr"/>
                      <a:r>
                        <a:rPr lang="en-US" sz="1100" i="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uracy CI 95%: 0.757 (0.709 – 0.801)</a:t>
                      </a:r>
                    </a:p>
                    <a:p>
                      <a:pPr algn="ctr"/>
                      <a:r>
                        <a:rPr lang="en-US" sz="1100" i="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ppa: 0. 340</a:t>
                      </a:r>
                    </a:p>
                    <a:p>
                      <a:pPr algn="ctr"/>
                      <a:r>
                        <a:rPr lang="en-US" sz="1100" i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100" i="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***</a:t>
                      </a:r>
                    </a:p>
                    <a:p>
                      <a:pPr algn="ctr"/>
                      <a:r>
                        <a:rPr lang="en-US" sz="1100" i="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: 0.618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2000" b="1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9288894"/>
                  </a:ext>
                </a:extLst>
              </a:tr>
            </a:tbl>
          </a:graphicData>
        </a:graphic>
      </p:graphicFrame>
      <p:sp>
        <p:nvSpPr>
          <p:cNvPr id="8" name="CuadroTexto 7">
            <a:extLst>
              <a:ext uri="{FF2B5EF4-FFF2-40B4-BE49-F238E27FC236}">
                <a16:creationId xmlns:a16="http://schemas.microsoft.com/office/drawing/2014/main" id="{C289D710-5FF0-BDB3-C53D-2A884F07F721}"/>
              </a:ext>
            </a:extLst>
          </p:cNvPr>
          <p:cNvSpPr txBox="1"/>
          <p:nvPr/>
        </p:nvSpPr>
        <p:spPr>
          <a:xfrm>
            <a:off x="11020938" y="2590255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15086432-D8F2-FBF2-FA5D-F68F93729C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2935" y="1420536"/>
            <a:ext cx="3008923" cy="1858010"/>
          </a:xfrm>
          <a:prstGeom prst="rect">
            <a:avLst/>
          </a:prstGeom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60C1A69C-F8CD-3ED2-C9EE-B91F12CBEC45}"/>
              </a:ext>
            </a:extLst>
          </p:cNvPr>
          <p:cNvSpPr txBox="1"/>
          <p:nvPr/>
        </p:nvSpPr>
        <p:spPr>
          <a:xfrm>
            <a:off x="834634" y="675701"/>
            <a:ext cx="2351926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isk of malnutrition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GLIM,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ale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11" name="Imagen 10">
            <a:extLst>
              <a:ext uri="{FF2B5EF4-FFF2-40B4-BE49-F238E27FC236}">
                <a16:creationId xmlns:a16="http://schemas.microsoft.com/office/drawing/2014/main" id="{CE8D0359-012A-B0E0-A95A-4F77C64DF4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74514" y="547175"/>
            <a:ext cx="3067448" cy="2925437"/>
          </a:xfrm>
          <a:prstGeom prst="rect">
            <a:avLst/>
          </a:prstGeom>
        </p:spPr>
      </p:pic>
      <p:pic>
        <p:nvPicPr>
          <p:cNvPr id="13" name="Imagen 12">
            <a:extLst>
              <a:ext uri="{FF2B5EF4-FFF2-40B4-BE49-F238E27FC236}">
                <a16:creationId xmlns:a16="http://schemas.microsoft.com/office/drawing/2014/main" id="{89894E5A-52CD-A92B-84C4-A1B8D9B276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922" y="4359386"/>
            <a:ext cx="4077842" cy="3429000"/>
          </a:xfrm>
          <a:prstGeom prst="rect">
            <a:avLst/>
          </a:prstGeom>
        </p:spPr>
      </p:pic>
      <p:sp>
        <p:nvSpPr>
          <p:cNvPr id="14" name="CuadroTexto 13">
            <a:extLst>
              <a:ext uri="{FF2B5EF4-FFF2-40B4-BE49-F238E27FC236}">
                <a16:creationId xmlns:a16="http://schemas.microsoft.com/office/drawing/2014/main" id="{CCC4798A-8C68-AB5E-A4B6-F5D1D869DE1D}"/>
              </a:ext>
            </a:extLst>
          </p:cNvPr>
          <p:cNvSpPr txBox="1"/>
          <p:nvPr/>
        </p:nvSpPr>
        <p:spPr>
          <a:xfrm>
            <a:off x="1215290" y="3759222"/>
            <a:ext cx="2351926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isk of malnutrition</a:t>
            </a:r>
          </a:p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(GLIM,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aphicFrame>
        <p:nvGraphicFramePr>
          <p:cNvPr id="15" name="Tabla 26">
            <a:extLst>
              <a:ext uri="{FF2B5EF4-FFF2-40B4-BE49-F238E27FC236}">
                <a16:creationId xmlns:a16="http://schemas.microsoft.com/office/drawing/2014/main" id="{B949B5A6-ED60-8D7D-97BC-3C967641D2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4845555"/>
              </p:ext>
            </p:extLst>
          </p:nvPr>
        </p:nvGraphicFramePr>
        <p:xfrm>
          <a:off x="4135763" y="5088204"/>
          <a:ext cx="3626922" cy="23012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14823">
                  <a:extLst>
                    <a:ext uri="{9D8B030D-6E8A-4147-A177-3AD203B41FA5}">
                      <a16:colId xmlns:a16="http://schemas.microsoft.com/office/drawing/2014/main" val="1619431056"/>
                    </a:ext>
                  </a:extLst>
                </a:gridCol>
                <a:gridCol w="965200">
                  <a:extLst>
                    <a:ext uri="{9D8B030D-6E8A-4147-A177-3AD203B41FA5}">
                      <a16:colId xmlns:a16="http://schemas.microsoft.com/office/drawing/2014/main" val="237871101"/>
                    </a:ext>
                  </a:extLst>
                </a:gridCol>
                <a:gridCol w="802640">
                  <a:extLst>
                    <a:ext uri="{9D8B030D-6E8A-4147-A177-3AD203B41FA5}">
                      <a16:colId xmlns:a16="http://schemas.microsoft.com/office/drawing/2014/main" val="155314303"/>
                    </a:ext>
                  </a:extLst>
                </a:gridCol>
                <a:gridCol w="844259">
                  <a:extLst>
                    <a:ext uri="{9D8B030D-6E8A-4147-A177-3AD203B41FA5}">
                      <a16:colId xmlns:a16="http://schemas.microsoft.com/office/drawing/2014/main" val="3197434678"/>
                    </a:ext>
                  </a:extLst>
                </a:gridCol>
              </a:tblGrid>
              <a:tr h="217643">
                <a:tc rowSpan="2" gridSpan="2">
                  <a:txBody>
                    <a:bodyPr/>
                    <a:lstStyle/>
                    <a:p>
                      <a:pPr algn="ctr"/>
                      <a:endParaRPr lang="en-US" sz="11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 h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dict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3411237"/>
                  </a:ext>
                </a:extLst>
              </a:tr>
              <a:tr h="358470">
                <a:tc gridSpan="2" v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 v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-nourish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ll-nourish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8253269"/>
                  </a:ext>
                </a:extLst>
              </a:tr>
              <a:tr h="358470">
                <a:tc rowSpan="2">
                  <a:txBody>
                    <a:bodyPr/>
                    <a:lstStyle/>
                    <a:p>
                      <a:pPr algn="ctr"/>
                      <a:endParaRPr lang="en-US" sz="11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1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bserv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-nourish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0171736"/>
                  </a:ext>
                </a:extLst>
              </a:tr>
              <a:tr h="358470">
                <a:tc v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ll-nourished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68284739"/>
                  </a:ext>
                </a:extLst>
              </a:tr>
              <a:tr h="642425">
                <a:tc gridSpan="4">
                  <a:txBody>
                    <a:bodyPr/>
                    <a:lstStyle/>
                    <a:p>
                      <a:pPr algn="ctr"/>
                      <a:r>
                        <a:rPr lang="en-US" sz="1100" i="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uracy CI 95%: 0.835 (0.746 – 0.903)</a:t>
                      </a:r>
                    </a:p>
                    <a:p>
                      <a:pPr algn="ctr"/>
                      <a:r>
                        <a:rPr lang="en-US" sz="1100" i="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ppa: 0. 638</a:t>
                      </a:r>
                    </a:p>
                    <a:p>
                      <a:pPr algn="ctr"/>
                      <a:r>
                        <a:rPr lang="en-US" sz="1100" i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1100" i="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***</a:t>
                      </a:r>
                    </a:p>
                    <a:p>
                      <a:pPr algn="ctr"/>
                      <a:r>
                        <a:rPr lang="en-US" sz="1100" i="0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C: 0.657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2000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2000" b="1" noProof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9288894"/>
                  </a:ext>
                </a:extLst>
              </a:tr>
            </a:tbl>
          </a:graphicData>
        </a:graphic>
      </p:graphicFrame>
      <p:pic>
        <p:nvPicPr>
          <p:cNvPr id="16" name="Imagen 15">
            <a:extLst>
              <a:ext uri="{FF2B5EF4-FFF2-40B4-BE49-F238E27FC236}">
                <a16:creationId xmlns:a16="http://schemas.microsoft.com/office/drawing/2014/main" id="{4F78CF22-3B01-0D36-B5FD-B4053C66E3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09064" y="4776105"/>
            <a:ext cx="3067448" cy="2925437"/>
          </a:xfrm>
          <a:prstGeom prst="rect">
            <a:avLst/>
          </a:prstGeom>
        </p:spPr>
      </p:pic>
      <p:sp>
        <p:nvSpPr>
          <p:cNvPr id="17" name="CuadroTexto 16">
            <a:extLst>
              <a:ext uri="{FF2B5EF4-FFF2-40B4-BE49-F238E27FC236}">
                <a16:creationId xmlns:a16="http://schemas.microsoft.com/office/drawing/2014/main" id="{93DEA896-F413-8999-1D49-42876F331411}"/>
              </a:ext>
            </a:extLst>
          </p:cNvPr>
          <p:cNvSpPr txBox="1"/>
          <p:nvPr/>
        </p:nvSpPr>
        <p:spPr>
          <a:xfrm>
            <a:off x="3602678" y="539750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025C2B2F-7EC5-715B-482F-453F5830795F}"/>
              </a:ext>
            </a:extLst>
          </p:cNvPr>
          <p:cNvSpPr txBox="1"/>
          <p:nvPr/>
        </p:nvSpPr>
        <p:spPr>
          <a:xfrm>
            <a:off x="7948542" y="539750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813F93F1-BC52-4AB2-CF91-7DA55D3BF838}"/>
              </a:ext>
            </a:extLst>
          </p:cNvPr>
          <p:cNvSpPr txBox="1"/>
          <p:nvPr/>
        </p:nvSpPr>
        <p:spPr>
          <a:xfrm>
            <a:off x="255148" y="3768695"/>
            <a:ext cx="4555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B22639A-63F4-AE8D-EBCE-5B18DE2E82A9}"/>
              </a:ext>
            </a:extLst>
          </p:cNvPr>
          <p:cNvSpPr txBox="1"/>
          <p:nvPr/>
        </p:nvSpPr>
        <p:spPr>
          <a:xfrm>
            <a:off x="3730190" y="4489207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A0E92B6F-133C-687B-EAC0-C140EAD9CA18}"/>
              </a:ext>
            </a:extLst>
          </p:cNvPr>
          <p:cNvSpPr txBox="1"/>
          <p:nvPr/>
        </p:nvSpPr>
        <p:spPr>
          <a:xfrm>
            <a:off x="8161154" y="4489207"/>
            <a:ext cx="42672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0739596F-8B37-8411-A051-2EA239DC2E81}"/>
              </a:ext>
            </a:extLst>
          </p:cNvPr>
          <p:cNvSpPr txBox="1"/>
          <p:nvPr/>
        </p:nvSpPr>
        <p:spPr>
          <a:xfrm>
            <a:off x="408214" y="221246"/>
            <a:ext cx="15366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/>
              <a:t>Supp</a:t>
            </a:r>
            <a:r>
              <a:rPr lang="es-ES" b="1" dirty="0"/>
              <a:t>. </a:t>
            </a:r>
            <a:r>
              <a:rPr lang="es-ES" b="1"/>
              <a:t>Figure 3</a:t>
            </a:r>
            <a:endParaRPr lang="es-ES" b="1" dirty="0"/>
          </a:p>
        </p:txBody>
      </p:sp>
    </p:spTree>
    <p:extLst>
      <p:ext uri="{BB962C8B-B14F-4D97-AF65-F5344CB8AC3E}">
        <p14:creationId xmlns:p14="http://schemas.microsoft.com/office/powerpoint/2010/main" val="21161895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</TotalTime>
  <Words>98</Words>
  <Application>Microsoft Macintosh PowerPoint</Application>
  <PresentationFormat>Personalizado</PresentationFormat>
  <Paragraphs>4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atim Boughanem</dc:creator>
  <cp:lastModifiedBy>Aura Herrera</cp:lastModifiedBy>
  <cp:revision>7</cp:revision>
  <dcterms:created xsi:type="dcterms:W3CDTF">2023-09-11T11:54:45Z</dcterms:created>
  <dcterms:modified xsi:type="dcterms:W3CDTF">2024-04-14T12:04:22Z</dcterms:modified>
</cp:coreProperties>
</file>